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83" d="100"/>
          <a:sy n="83" d="100"/>
        </p:scale>
        <p:origin x="45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629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828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55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609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250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111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074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448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7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74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153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60D58-5C00-4E3B-89C4-DBF202C5FDDA}" type="datetimeFigureOut">
              <a:rPr lang="en-US" smtClean="0"/>
              <a:t>10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AEE66-50C8-4B1D-8A03-1CF5E1CB46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46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73366" y="828675"/>
            <a:ext cx="3698559" cy="1076325"/>
          </a:xfrm>
        </p:spPr>
        <p:txBody>
          <a:bodyPr>
            <a:no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Photomicrograph of hematoxylin and eosin stained sections (A &amp; C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ybridization (B&amp; D) of parallel sections of the hepatopancreas (A &amp; B) and cuticular epithelium (C &amp; D) of Specific Pathogen Free (SPF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aeus vannamei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reaction is observable by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t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ybridization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1754" y="174471"/>
            <a:ext cx="3184421" cy="31211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574" y="3388958"/>
            <a:ext cx="3203962" cy="316995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703" y="155420"/>
            <a:ext cx="3188387" cy="318838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703" y="3409950"/>
            <a:ext cx="3178991" cy="314896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4310574" y="174471"/>
            <a:ext cx="5290626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4500" dirty="0"/>
              <a:t>A                      B</a:t>
            </a:r>
          </a:p>
          <a:p>
            <a:endParaRPr lang="es-MX" sz="4500" dirty="0"/>
          </a:p>
          <a:p>
            <a:endParaRPr lang="es-MX" sz="4500" dirty="0"/>
          </a:p>
          <a:p>
            <a:endParaRPr lang="es-MX" sz="4500" dirty="0"/>
          </a:p>
          <a:p>
            <a:endParaRPr lang="es-MX" sz="4500" dirty="0"/>
          </a:p>
          <a:p>
            <a:r>
              <a:rPr lang="es-MX" sz="4500" dirty="0"/>
              <a:t>C                       D</a:t>
            </a:r>
          </a:p>
        </p:txBody>
      </p:sp>
    </p:spTree>
    <p:extLst>
      <p:ext uri="{BB962C8B-B14F-4D97-AF65-F5344CB8AC3E}">
        <p14:creationId xmlns:p14="http://schemas.microsoft.com/office/powerpoint/2010/main" val="21271073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6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l Figure S1. Photomicrograph of hematoxylin and eosin stained sections (A &amp; C) and in situ hybridization (B&amp; D) of parallel sections of the hepatopancreas (A &amp; B) and cuticular epithelium (C &amp; D) of Specific Pathogen Free (SPF) Penaeus vannamei. No reaction is observable by in situ hybridiz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&amp;E histology</dc:title>
  <dc:creator>Dhar, Arun K - (adhar)</dc:creator>
  <cp:lastModifiedBy>MDPI</cp:lastModifiedBy>
  <cp:revision>4</cp:revision>
  <dcterms:created xsi:type="dcterms:W3CDTF">2022-09-22T19:08:28Z</dcterms:created>
  <dcterms:modified xsi:type="dcterms:W3CDTF">2022-10-09T08:25:29Z</dcterms:modified>
</cp:coreProperties>
</file>